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7" r:id="rId2"/>
  </p:sldIdLst>
  <p:sldSz cx="9144000" cy="6858000" type="screen4x3"/>
  <p:notesSz cx="6858000" cy="994568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00008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40" autoAdjust="0"/>
    <p:restoredTop sz="94660"/>
  </p:normalViewPr>
  <p:slideViewPr>
    <p:cSldViewPr snapToGrid="0" snapToObjects="1">
      <p:cViewPr varScale="1">
        <p:scale>
          <a:sx n="56" d="100"/>
          <a:sy n="56" d="100"/>
        </p:scale>
        <p:origin x="1304" y="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E89D7E-8A48-0E46-9167-8DFA57CD5B16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42975" y="746125"/>
            <a:ext cx="4972050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24202"/>
            <a:ext cx="5486400" cy="447556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5A11F-1826-3642-BBF7-EA236A47CF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392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084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028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8524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3845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6086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962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9970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9016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072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748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0730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02CA3-5EC9-8141-A8AB-F3A67208CBD2}" type="datetimeFigureOut">
              <a:rPr kumimoji="1" lang="ja-JP" altLang="en-US" smtClean="0"/>
              <a:t>2019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382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7130C44-4072-4C70-A7C0-5F3848F27425}"/>
              </a:ext>
            </a:extLst>
          </p:cNvPr>
          <p:cNvSpPr txBox="1"/>
          <p:nvPr/>
        </p:nvSpPr>
        <p:spPr>
          <a:xfrm>
            <a:off x="3305904" y="-28138"/>
            <a:ext cx="27909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Fig. S2  Yamamoto et al.</a:t>
            </a:r>
            <a:endParaRPr kumimoji="1" lang="ja-JP" altLang="en-US" sz="10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9720" y="666750"/>
            <a:ext cx="6004560" cy="5524500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B1014268-DCD3-4640-9D9F-CF37BB1E9440}"/>
              </a:ext>
            </a:extLst>
          </p:cNvPr>
          <p:cNvSpPr/>
          <p:nvPr/>
        </p:nvSpPr>
        <p:spPr>
          <a:xfrm>
            <a:off x="948690" y="6384160"/>
            <a:ext cx="898398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 Microscopic images of CLB cream formulations. Magnification: ×50, ×200, and ×1000. </a:t>
            </a:r>
          </a:p>
          <a:p>
            <a:pPr algn="just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: polarized light; WL: white light.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203381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1</TotalTime>
  <Words>39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ホワイト</vt:lpstr>
      <vt:lpstr>PowerPoint プレゼンテーション</vt:lpstr>
    </vt:vector>
  </TitlesOfParts>
  <Company>帝京平成大学薬学部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佳久</dc:creator>
  <cp:lastModifiedBy>山本　佳久</cp:lastModifiedBy>
  <cp:revision>75</cp:revision>
  <cp:lastPrinted>2019-08-08T09:08:55Z</cp:lastPrinted>
  <dcterms:created xsi:type="dcterms:W3CDTF">2017-02-17T08:52:02Z</dcterms:created>
  <dcterms:modified xsi:type="dcterms:W3CDTF">2019-10-21T10:08:15Z</dcterms:modified>
</cp:coreProperties>
</file>